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  <p:sldId id="256" r:id="rId3"/>
    <p:sldId id="257" r:id="rId4"/>
    <p:sldId id="259" r:id="rId5"/>
    <p:sldId id="260" r:id="rId6"/>
    <p:sldId id="263" r:id="rId7"/>
    <p:sldId id="261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73"/>
  </p:normalViewPr>
  <p:slideViewPr>
    <p:cSldViewPr snapToGrid="0" snapToObjects="1">
      <p:cViewPr varScale="1">
        <p:scale>
          <a:sx n="119" d="100"/>
          <a:sy n="119" d="100"/>
        </p:scale>
        <p:origin x="3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34F4E2-3CD3-DC4F-BA40-2D91FA0536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9409B31-22D0-884A-B537-01D6614B6C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97FFBD-B590-704F-8451-18CDD4844C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F1611-B3AE-5B4D-A89A-A7C9E93F082E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453AAF-EE0B-3C4D-A090-3987F57C10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8C8B35-F333-F74C-B863-E8612E23F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C5342-DE6A-084C-A031-606B04B792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9978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01C1E2-95E9-644C-A64E-4BB0EC52BD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F37A08-2693-2546-8DA5-C5F70A8BD6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FC5D98-8EE1-9943-A3A9-525C9B2D02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F1611-B3AE-5B4D-A89A-A7C9E93F082E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626501-1089-0D47-AA6D-03672B97DF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18C2C7-5BF4-074B-A07E-CADB7E95E8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C5342-DE6A-084C-A031-606B04B792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504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B1245C6-BBA2-2849-9811-EA2F2F1C6A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A4555D9-E157-1745-9BC7-9690C01089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3A85BD-E32B-0849-8649-3D5A8FC8F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F1611-B3AE-5B4D-A89A-A7C9E93F082E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1CA28C-7DEC-2D4B-8AE4-0A0CEE3FB6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BB582B-6A12-F642-AFC3-AE66D91719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C5342-DE6A-084C-A031-606B04B792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808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C0D983-F609-4E42-8D0A-01C3E4238A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766BC6-6E42-C44C-99A9-458A4A419C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40A831-CD90-CE45-AFB4-9A00492CF1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F1611-B3AE-5B4D-A89A-A7C9E93F082E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C964EE-7E7B-FC4D-BAF5-E4C10333A4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1E1E73-BFBE-A64F-8424-3CD6C718BB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C5342-DE6A-084C-A031-606B04B792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794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CF3BB7-F17F-0941-AAF2-77BABBE184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2BD35F-1DA5-0C4B-97FD-0491F73C0B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F9924B-EFCD-DA4D-96B1-261CABFA2D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F1611-B3AE-5B4D-A89A-A7C9E93F082E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6C3B41-7B18-6B40-9B8F-CE9A3A75BE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9737F6-AE5B-8D44-B8A6-93BC399F77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C5342-DE6A-084C-A031-606B04B792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6394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A3E9A3-BCC5-BE47-BEFF-950FB578CC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E4487A-55F3-CC4F-8BA7-68C5E02C12C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07F4C4-B904-9549-8FC3-6FD55E5796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911B31-BD22-A542-9B17-C90BF1AAA4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F1611-B3AE-5B4D-A89A-A7C9E93F082E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70AF49-6870-EC4C-98B7-4F72030DC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919B9C-7144-DD44-BEFD-4B1C2F4AD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C5342-DE6A-084C-A031-606B04B792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115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D1AECC-EFAE-8D4E-AD68-5F5635C151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923DBE-639C-0A4F-8AB5-991B6BE1EE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425962-614D-E044-B93F-2BFB78EC5F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E69B334-1462-4948-AFA4-4AD3E800045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A33E361-D7C1-6644-B8C7-E8459AA953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0D24FC-467D-5C48-839C-53B2430D0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F1611-B3AE-5B4D-A89A-A7C9E93F082E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F7B15F0-EE13-1D44-B458-544DF53CDD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A76A819-4337-4841-BC0B-6FF08516CA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C5342-DE6A-084C-A031-606B04B792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48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B35A67-F4CB-4D43-A842-7EBFF4FE2D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E581861-CAB8-0943-9D09-9B09774DEA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F1611-B3AE-5B4D-A89A-A7C9E93F082E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180DEC7-F03B-3A4D-8D9A-8E71F83E48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52700FD-1DB2-C847-A662-5DD3BC2500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C5342-DE6A-084C-A031-606B04B792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12582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2878B8D-8E3A-524E-A94C-35D462E388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F1611-B3AE-5B4D-A89A-A7C9E93F082E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A9E6559-D21F-6F46-BF71-AC0337F14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855186-2478-C44D-BF31-F99B2D0331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C5342-DE6A-084C-A031-606B04B792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6364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FCD1D1-619A-1048-8527-C68D8C12DE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94855E-438B-0D4D-9B1D-BC7BABEB59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C755DF6-FD0D-FB40-A5EE-22D29F73B1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07A0C4-675F-C74D-9C65-A2DDC00616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F1611-B3AE-5B4D-A89A-A7C9E93F082E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9AED20-DAB8-E74E-B695-6B683B453D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7CC5AD-3D81-9A44-83CF-ECC3AD71CA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C5342-DE6A-084C-A031-606B04B792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883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C68DCC-B6A0-6046-9C57-1E691AF874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1B96902-94AB-FC42-853C-25836BB7DF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3C3D2A-38F9-1E47-A82F-B6ACD0AC29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A61139-B088-4845-ABCB-59145CE93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F1611-B3AE-5B4D-A89A-A7C9E93F082E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072CC7-F67A-324B-B625-9E585F547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7A3832-BBCE-704E-8103-AC7309BBA6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C5342-DE6A-084C-A031-606B04B792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730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94DF838-5FD4-734F-AA3F-5D4D4C9CCD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080612-A73C-5F48-B06A-4EC70944D6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46D275-66A3-8444-9EE7-48ADDF94D8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5F1611-B3AE-5B4D-A89A-A7C9E93F082E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66396F-E298-AC40-AD9E-38105705FFC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DF7C36-B573-D94E-8616-2C90ED50DE8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9C5342-DE6A-084C-A031-606B04B792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042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4F78119-2DE5-7B40-B2DB-ECE95C131626}"/>
              </a:ext>
            </a:extLst>
          </p:cNvPr>
          <p:cNvSpPr txBox="1"/>
          <p:nvPr/>
        </p:nvSpPr>
        <p:spPr>
          <a:xfrm>
            <a:off x="1016000" y="417689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D629439-FB26-534B-8660-CAC7F56CF3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88177" y="282222"/>
            <a:ext cx="4361803" cy="6094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45141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F33CC0C-E431-B747-93C2-6AE4AE7BA9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5403274" y="1477673"/>
            <a:ext cx="5348342" cy="3812783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3183DA70-A72D-884B-BB74-C65300794E39}"/>
              </a:ext>
            </a:extLst>
          </p:cNvPr>
          <p:cNvSpPr/>
          <p:nvPr/>
        </p:nvSpPr>
        <p:spPr>
          <a:xfrm>
            <a:off x="6265334" y="2280357"/>
            <a:ext cx="1591734" cy="27770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C8CC1C6-57E3-9647-BE61-0608A9A4951C}"/>
              </a:ext>
            </a:extLst>
          </p:cNvPr>
          <p:cNvSpPr txBox="1"/>
          <p:nvPr/>
        </p:nvSpPr>
        <p:spPr>
          <a:xfrm>
            <a:off x="1106311" y="356330"/>
            <a:ext cx="9284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Fig 1C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C1851A8-1DBC-9C4F-99C4-6656CAE1F95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2021" t="20550" r="9933" b="60187"/>
          <a:stretch/>
        </p:blipFill>
        <p:spPr>
          <a:xfrm>
            <a:off x="983762" y="1603024"/>
            <a:ext cx="3622105" cy="2562576"/>
          </a:xfrm>
          <a:prstGeom prst="rect">
            <a:avLst/>
          </a:prstGeom>
        </p:spPr>
      </p:pic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CFA3A189-16E7-314D-A39E-22E919FE083C}"/>
              </a:ext>
            </a:extLst>
          </p:cNvPr>
          <p:cNvCxnSpPr/>
          <p:nvPr/>
        </p:nvCxnSpPr>
        <p:spPr>
          <a:xfrm>
            <a:off x="3849511" y="2664178"/>
            <a:ext cx="2321542" cy="22013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797739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2A5D8D4-BFA9-7342-860B-590F64D55F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5350907" y="754716"/>
            <a:ext cx="6796915" cy="5409654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11462566-32CD-7D46-A014-B7400D11BE79}"/>
              </a:ext>
            </a:extLst>
          </p:cNvPr>
          <p:cNvSpPr/>
          <p:nvPr/>
        </p:nvSpPr>
        <p:spPr>
          <a:xfrm>
            <a:off x="7386452" y="2743200"/>
            <a:ext cx="617516" cy="169817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D2AEAFE-0F7A-D44C-9D05-A748C5E99BD1}"/>
              </a:ext>
            </a:extLst>
          </p:cNvPr>
          <p:cNvSpPr txBox="1"/>
          <p:nvPr/>
        </p:nvSpPr>
        <p:spPr>
          <a:xfrm>
            <a:off x="605282" y="270269"/>
            <a:ext cx="243079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Fig 1D Right panel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076E533F-A931-A149-A7D8-765BD048D410}"/>
              </a:ext>
            </a:extLst>
          </p:cNvPr>
          <p:cNvCxnSpPr/>
          <p:nvPr/>
        </p:nvCxnSpPr>
        <p:spPr>
          <a:xfrm flipH="1">
            <a:off x="4097867" y="3680178"/>
            <a:ext cx="3288585" cy="239324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B81299F2-7FF0-A741-BBB8-640FF70711C0}"/>
              </a:ext>
            </a:extLst>
          </p:cNvPr>
          <p:cNvSpPr txBox="1"/>
          <p:nvPr/>
        </p:nvSpPr>
        <p:spPr>
          <a:xfrm>
            <a:off x="756664" y="6040946"/>
            <a:ext cx="44531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pliced out lane and the two remaining parts </a:t>
            </a:r>
          </a:p>
          <a:p>
            <a:r>
              <a:rPr lang="en-US" dirty="0"/>
              <a:t>Of the gel were fused together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A328049A-D19D-2C4E-8655-DD4818AFDEB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7126" t="40378" b="39803"/>
          <a:stretch/>
        </p:blipFill>
        <p:spPr>
          <a:xfrm>
            <a:off x="866546" y="1523999"/>
            <a:ext cx="3231321" cy="39120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90487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C1FD66E-37A5-2342-9213-20A6AD7394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6438198" y="618641"/>
            <a:ext cx="5127365" cy="603496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34C52EFE-7734-E043-AD79-27540B12E0CB}"/>
              </a:ext>
            </a:extLst>
          </p:cNvPr>
          <p:cNvSpPr/>
          <p:nvPr/>
        </p:nvSpPr>
        <p:spPr>
          <a:xfrm>
            <a:off x="9368753" y="2833511"/>
            <a:ext cx="1457291" cy="15128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8BCEED0-C420-524F-93EF-38A20874800A}"/>
              </a:ext>
            </a:extLst>
          </p:cNvPr>
          <p:cNvSpPr txBox="1"/>
          <p:nvPr/>
        </p:nvSpPr>
        <p:spPr>
          <a:xfrm>
            <a:off x="498764" y="373187"/>
            <a:ext cx="17432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1E left panel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86942BD-B462-E842-878B-B49696402D9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9261" r="46540"/>
          <a:stretch/>
        </p:blipFill>
        <p:spPr>
          <a:xfrm>
            <a:off x="632421" y="1603312"/>
            <a:ext cx="3243834" cy="3454110"/>
          </a:xfrm>
          <a:prstGeom prst="rect">
            <a:avLst/>
          </a:prstGeom>
        </p:spPr>
      </p:pic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E879A886-E333-6C44-BEAF-79C6A7D50128}"/>
              </a:ext>
            </a:extLst>
          </p:cNvPr>
          <p:cNvCxnSpPr>
            <a:cxnSpLocks/>
          </p:cNvCxnSpPr>
          <p:nvPr/>
        </p:nvCxnSpPr>
        <p:spPr>
          <a:xfrm>
            <a:off x="2664178" y="2652889"/>
            <a:ext cx="6704575" cy="4741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775651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AA8F507-AE4A-1047-A645-0119CE4FD54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1720"/>
          <a:stretch/>
        </p:blipFill>
        <p:spPr>
          <a:xfrm rot="16388845">
            <a:off x="6360432" y="726281"/>
            <a:ext cx="5518547" cy="5368466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A8162621-FCCA-0849-BF75-950C791D2F6A}"/>
              </a:ext>
            </a:extLst>
          </p:cNvPr>
          <p:cNvSpPr/>
          <p:nvPr/>
        </p:nvSpPr>
        <p:spPr>
          <a:xfrm>
            <a:off x="6582888" y="1567543"/>
            <a:ext cx="1991096" cy="29094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29AA8E6-7071-A642-A431-C2F8E9444050}"/>
              </a:ext>
            </a:extLst>
          </p:cNvPr>
          <p:cNvSpPr txBox="1"/>
          <p:nvPr/>
        </p:nvSpPr>
        <p:spPr>
          <a:xfrm>
            <a:off x="498764" y="373187"/>
            <a:ext cx="19082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1E right panel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E6F14252-A8B5-D944-855F-954D73327CC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9261" r="46540"/>
          <a:stretch/>
        </p:blipFill>
        <p:spPr>
          <a:xfrm>
            <a:off x="971088" y="1567543"/>
            <a:ext cx="3243834" cy="3454110"/>
          </a:xfrm>
          <a:prstGeom prst="rect">
            <a:avLst/>
          </a:prstGeom>
        </p:spPr>
      </p:pic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A62238D2-EE61-9844-9DE7-23FB1E9C4D91}"/>
              </a:ext>
            </a:extLst>
          </p:cNvPr>
          <p:cNvCxnSpPr>
            <a:cxnSpLocks/>
          </p:cNvCxnSpPr>
          <p:nvPr/>
        </p:nvCxnSpPr>
        <p:spPr>
          <a:xfrm flipV="1">
            <a:off x="3984978" y="2551289"/>
            <a:ext cx="2597910" cy="7902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178324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E42694E-C7A8-5D43-A8DF-97A3DA4687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60534" y="901060"/>
            <a:ext cx="5667584" cy="464919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D72ACBC-720F-024E-9317-F238AEB85AD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379" r="45125"/>
          <a:stretch/>
        </p:blipFill>
        <p:spPr bwMode="auto">
          <a:xfrm>
            <a:off x="1863551" y="1862664"/>
            <a:ext cx="2901580" cy="30028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4FBDE0F6-BEAB-0E4A-B3CF-9A51A7C80FE5}"/>
              </a:ext>
            </a:extLst>
          </p:cNvPr>
          <p:cNvSpPr/>
          <p:nvPr/>
        </p:nvSpPr>
        <p:spPr>
          <a:xfrm>
            <a:off x="8150578" y="3225655"/>
            <a:ext cx="1128889" cy="13915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3737595C-9ECD-5F49-8A39-8FC5993CCBE2}"/>
              </a:ext>
            </a:extLst>
          </p:cNvPr>
          <p:cNvCxnSpPr>
            <a:cxnSpLocks/>
          </p:cNvCxnSpPr>
          <p:nvPr/>
        </p:nvCxnSpPr>
        <p:spPr>
          <a:xfrm flipV="1">
            <a:off x="3454400" y="3872089"/>
            <a:ext cx="4786489" cy="69991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688ABB15-E1D1-9B4A-B20B-305FC2F6029B}"/>
              </a:ext>
            </a:extLst>
          </p:cNvPr>
          <p:cNvSpPr txBox="1"/>
          <p:nvPr/>
        </p:nvSpPr>
        <p:spPr>
          <a:xfrm>
            <a:off x="857935" y="340913"/>
            <a:ext cx="18458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1G Left panel</a:t>
            </a:r>
          </a:p>
        </p:txBody>
      </p:sp>
    </p:spTree>
    <p:extLst>
      <p:ext uri="{BB962C8B-B14F-4D97-AF65-F5344CB8AC3E}">
        <p14:creationId xmlns:p14="http://schemas.microsoft.com/office/powerpoint/2010/main" val="38247330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E0100CB-D582-9549-8483-B569823719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90589" y="1330038"/>
            <a:ext cx="5301803" cy="4934197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44C23F48-7240-A049-8D1F-8A2FBE32B432}"/>
              </a:ext>
            </a:extLst>
          </p:cNvPr>
          <p:cNvSpPr/>
          <p:nvPr/>
        </p:nvSpPr>
        <p:spPr>
          <a:xfrm>
            <a:off x="8253351" y="2829297"/>
            <a:ext cx="1270659" cy="15645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1BCE5FD-03C6-4C42-8142-EFC2D405601C}"/>
              </a:ext>
            </a:extLst>
          </p:cNvPr>
          <p:cNvSpPr txBox="1"/>
          <p:nvPr/>
        </p:nvSpPr>
        <p:spPr>
          <a:xfrm>
            <a:off x="857935" y="373187"/>
            <a:ext cx="19514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1G right panel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02AD2BF-6CDD-4749-9280-B8FC93373B7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9261" r="46540"/>
          <a:stretch/>
        </p:blipFill>
        <p:spPr>
          <a:xfrm>
            <a:off x="971088" y="1567543"/>
            <a:ext cx="3243834" cy="3454110"/>
          </a:xfrm>
          <a:prstGeom prst="rect">
            <a:avLst/>
          </a:prstGeom>
        </p:spPr>
      </p:pic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E07C2987-2A01-BE41-B53E-DF3CD80CEBB7}"/>
              </a:ext>
            </a:extLst>
          </p:cNvPr>
          <p:cNvCxnSpPr>
            <a:cxnSpLocks/>
          </p:cNvCxnSpPr>
          <p:nvPr/>
        </p:nvCxnSpPr>
        <p:spPr>
          <a:xfrm flipV="1">
            <a:off x="3702756" y="3635022"/>
            <a:ext cx="4550595" cy="92568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249344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34</Words>
  <Application>Microsoft Macintosh PowerPoint</Application>
  <PresentationFormat>Widescreen</PresentationFormat>
  <Paragraphs>9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mple Notani</dc:creator>
  <cp:lastModifiedBy>Sanjeev Galande</cp:lastModifiedBy>
  <cp:revision>9</cp:revision>
  <dcterms:created xsi:type="dcterms:W3CDTF">2021-12-03T08:03:42Z</dcterms:created>
  <dcterms:modified xsi:type="dcterms:W3CDTF">2021-12-18T13:24:40Z</dcterms:modified>
</cp:coreProperties>
</file>